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BG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794"/>
  </p:normalViewPr>
  <p:slideViewPr>
    <p:cSldViewPr snapToGrid="0" snapToObjects="1">
      <p:cViewPr varScale="1">
        <p:scale>
          <a:sx n="108" d="100"/>
          <a:sy n="108" d="100"/>
        </p:scale>
        <p:origin x="7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59BC49-65BB-EB45-83BC-CF99405AFA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BG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F7FA2FA-DD46-CB42-99A9-13CA8EE742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B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ED49F9-3F05-4343-96D6-C19B0A449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5EF5A-C057-E744-834E-ED153BA67168}" type="datetimeFigureOut">
              <a:rPr lang="en-BG" smtClean="0"/>
              <a:t>13.09.21</a:t>
            </a:fld>
            <a:endParaRPr lang="en-B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61353D-F25B-6349-8CC0-FA0C76FA3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B566BC-17BD-F14F-974A-31A6F5079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B6566-4FA9-8F46-A6F7-B302C45B735E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2061281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CB526B-6F77-894F-8152-AE477B2BED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B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8B812A-7DB0-954D-9014-8701C3E278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A8F238-EE47-6349-BA57-F7335C90E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5EF5A-C057-E744-834E-ED153BA67168}" type="datetimeFigureOut">
              <a:rPr lang="en-BG" smtClean="0"/>
              <a:t>13.09.21</a:t>
            </a:fld>
            <a:endParaRPr lang="en-B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F6E4CD-D126-0F43-9DEC-A38E0B309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57FE9B-30FF-084C-A702-63140C49F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B6566-4FA9-8F46-A6F7-B302C45B735E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3217451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D2436C2-781D-F844-BE26-CD9748791F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B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B0722F-FEEC-FC4A-94A2-49D3A11EF6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42415B-B5FB-CE4F-B42D-4EB9CB484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5EF5A-C057-E744-834E-ED153BA67168}" type="datetimeFigureOut">
              <a:rPr lang="en-BG" smtClean="0"/>
              <a:t>13.09.21</a:t>
            </a:fld>
            <a:endParaRPr lang="en-B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74A98D-9FAA-4446-A126-E4EC83B1A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F1F426-66C7-3E4C-B582-20F3ED7BB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B6566-4FA9-8F46-A6F7-B302C45B735E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3396058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E7A25C-3CC8-534B-A169-158BA6ADE3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B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BC66CA-8260-0048-8005-D8484A90E4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7AC584-E18A-F945-8B19-41ADB59A4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5EF5A-C057-E744-834E-ED153BA67168}" type="datetimeFigureOut">
              <a:rPr lang="en-BG" smtClean="0"/>
              <a:t>13.09.21</a:t>
            </a:fld>
            <a:endParaRPr lang="en-B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BDA4BF-1CFB-134C-A68D-A21D7F687E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8EE14C-0298-CA41-A89A-7AA0F88FE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B6566-4FA9-8F46-A6F7-B302C45B735E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3878083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57547E-1A97-4E43-8E0E-96E7C281C0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B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BFD1E2-0CEC-C443-BDF8-53AA622749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4FB6F6-635E-BA43-AEAA-21ACD23CE7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5EF5A-C057-E744-834E-ED153BA67168}" type="datetimeFigureOut">
              <a:rPr lang="en-BG" smtClean="0"/>
              <a:t>13.09.21</a:t>
            </a:fld>
            <a:endParaRPr lang="en-B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80A952-CAB3-B24B-B40F-FDF60B8A8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10F95E-E299-A644-A1CB-DAB2AD3F97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B6566-4FA9-8F46-A6F7-B302C45B735E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676627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0791B9-39EA-0F4E-A098-7A783E6E25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B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0C64BD-23A6-0B43-B8CA-FDCDC14C78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G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C02ED5-06CA-E446-9D7E-1DEA30BD47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G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1C2172-DDED-E64C-9236-C2473CF2B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5EF5A-C057-E744-834E-ED153BA67168}" type="datetimeFigureOut">
              <a:rPr lang="en-BG" smtClean="0"/>
              <a:t>13.09.21</a:t>
            </a:fld>
            <a:endParaRPr lang="en-B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B52E13-E6EA-4246-B1B8-C64A748F1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46D955-3510-154E-BE73-44F9D66995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B6566-4FA9-8F46-A6F7-B302C45B735E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664327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62B992-A01C-FC4B-BA99-977949533D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B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9E7514-D710-B844-8F58-9616F83BA0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DC6DEE-BAB5-2F42-BF17-E4D1DEE53E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G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BB2E1F-F592-6347-A6F2-C897DE96B2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8FB85FE-BAEC-FF47-940D-CADD193F62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G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6F1B153-A69C-B14E-B57F-BBF40A457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5EF5A-C057-E744-834E-ED153BA67168}" type="datetimeFigureOut">
              <a:rPr lang="en-BG" smtClean="0"/>
              <a:t>13.09.21</a:t>
            </a:fld>
            <a:endParaRPr lang="en-BG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4838EE-171F-DD40-AB98-385206D7BA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52B7B58-7D8C-0740-A39F-0CEFF228F0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B6566-4FA9-8F46-A6F7-B302C45B735E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17690960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54B4B5-EDE9-5E4F-8D23-9B54874AE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BG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2C0E65-F54A-0442-911C-1E8756B5C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5EF5A-C057-E744-834E-ED153BA67168}" type="datetimeFigureOut">
              <a:rPr lang="en-BG" smtClean="0"/>
              <a:t>13.09.21</a:t>
            </a:fld>
            <a:endParaRPr lang="en-BG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AF5B09-A56E-AB4C-AD5C-7087062FEA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4F5E66-8A2F-314E-85B8-C345D96538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B6566-4FA9-8F46-A6F7-B302C45B735E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2410742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164CFEE-A54D-D245-B270-DB25D0088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5EF5A-C057-E744-834E-ED153BA67168}" type="datetimeFigureOut">
              <a:rPr lang="en-BG" smtClean="0"/>
              <a:t>13.09.21</a:t>
            </a:fld>
            <a:endParaRPr lang="en-BG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7D121F-A9A2-5D49-AE94-624A2DAF2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2815DAC-27DA-7D45-AD60-CD94280AD9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B6566-4FA9-8F46-A6F7-B302C45B735E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3512877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2CD339-70E6-244C-8028-431F681EA6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B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504003-6D2B-7049-92EA-CB147C8933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15B67C-0474-E34D-A190-C353FBC1CC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B0468C-7A9D-5C45-A876-65247FA444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5EF5A-C057-E744-834E-ED153BA67168}" type="datetimeFigureOut">
              <a:rPr lang="en-BG" smtClean="0"/>
              <a:t>13.09.21</a:t>
            </a:fld>
            <a:endParaRPr lang="en-B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8AFA0-8AED-7B45-977C-6783A1A797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D72436-9F64-D944-9991-D252889CFD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B6566-4FA9-8F46-A6F7-B302C45B735E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1132837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8883CC-6022-3F43-AA59-AD4BD9660F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BG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870F1AC-549E-F64C-A598-72561674C4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B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4B27D4-446C-1B4D-9F14-936F86F815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C02BAE-98B0-474E-A332-DE79866D1B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5EF5A-C057-E744-834E-ED153BA67168}" type="datetimeFigureOut">
              <a:rPr lang="en-BG" smtClean="0"/>
              <a:t>13.09.21</a:t>
            </a:fld>
            <a:endParaRPr lang="en-B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EBA870-F41C-A647-95E3-3AB3D9DFC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02303E-AEB5-D740-B732-BC4053A79C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B6566-4FA9-8F46-A6F7-B302C45B735E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1589205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206957-9C8B-8A40-8977-BDE8220B22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B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C90511-05BA-964D-BF54-B762DA78C3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2F5EA4-64CD-1747-B15F-0ABCE547A4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55EF5A-C057-E744-834E-ED153BA67168}" type="datetimeFigureOut">
              <a:rPr lang="en-BG" smtClean="0"/>
              <a:t>13.09.21</a:t>
            </a:fld>
            <a:endParaRPr lang="en-B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E24E18-136D-3E47-93AA-0775613645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B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4585CC-BC04-6443-93C8-94EFE9CB9D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5B6566-4FA9-8F46-A6F7-B302C45B735E}" type="slidenum">
              <a:rPr lang="en-BG" smtClean="0"/>
              <a:t>‹#›</a:t>
            </a:fld>
            <a:endParaRPr lang="en-BG"/>
          </a:p>
        </p:txBody>
      </p:sp>
    </p:spTree>
    <p:extLst>
      <p:ext uri="{BB962C8B-B14F-4D97-AF65-F5344CB8AC3E}">
        <p14:creationId xmlns:p14="http://schemas.microsoft.com/office/powerpoint/2010/main" val="3836851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BG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16D4A6AE-8B68-A54D-97FE-5073C4EDE3CB}"/>
              </a:ext>
            </a:extLst>
          </p:cNvPr>
          <p:cNvGrpSpPr/>
          <p:nvPr/>
        </p:nvGrpSpPr>
        <p:grpSpPr>
          <a:xfrm>
            <a:off x="113297" y="828796"/>
            <a:ext cx="4800600" cy="4704728"/>
            <a:chOff x="344789" y="828796"/>
            <a:chExt cx="4800600" cy="470472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9CD2415-FDB1-B24A-A681-EBB71289613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4789" y="828796"/>
              <a:ext cx="4800600" cy="18669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E95AC98-DED8-134A-B5C5-7667A62AC20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87665" y="2803024"/>
              <a:ext cx="4572000" cy="2730500"/>
            </a:xfrm>
            <a:prstGeom prst="rect">
              <a:avLst/>
            </a:prstGeom>
          </p:spPr>
        </p:pic>
        <p:sp>
          <p:nvSpPr>
            <p:cNvPr id="8" name="Data 7">
              <a:extLst>
                <a:ext uri="{FF2B5EF4-FFF2-40B4-BE49-F238E27FC236}">
                  <a16:creationId xmlns:a16="http://schemas.microsoft.com/office/drawing/2014/main" id="{8E7378B6-487E-F94E-9B33-7F0E0807FBB4}"/>
                </a:ext>
              </a:extLst>
            </p:cNvPr>
            <p:cNvSpPr/>
            <p:nvPr/>
          </p:nvSpPr>
          <p:spPr>
            <a:xfrm>
              <a:off x="697214" y="2695696"/>
              <a:ext cx="520700" cy="91440"/>
            </a:xfrm>
            <a:prstGeom prst="flowChartInputOutput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en-GB" sz="1100"/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A5B64B5E-ACB5-8D47-82CD-ED8054C87582}"/>
              </a:ext>
            </a:extLst>
          </p:cNvPr>
          <p:cNvGrpSpPr/>
          <p:nvPr/>
        </p:nvGrpSpPr>
        <p:grpSpPr>
          <a:xfrm>
            <a:off x="2060595" y="404827"/>
            <a:ext cx="4398080" cy="4132757"/>
            <a:chOff x="1991145" y="844666"/>
            <a:chExt cx="4398080" cy="4132757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CDC13839-6349-974A-BB73-D954AAC608B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002721" y="844666"/>
              <a:ext cx="3888794" cy="1839443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51DA30B1-7BA6-9846-9921-B489A825489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991145" y="2805723"/>
              <a:ext cx="4398080" cy="2171700"/>
            </a:xfrm>
            <a:prstGeom prst="rect">
              <a:avLst/>
            </a:prstGeom>
          </p:spPr>
        </p:pic>
        <p:sp>
          <p:nvSpPr>
            <p:cNvPr id="13" name="Data 12">
              <a:extLst>
                <a:ext uri="{FF2B5EF4-FFF2-40B4-BE49-F238E27FC236}">
                  <a16:creationId xmlns:a16="http://schemas.microsoft.com/office/drawing/2014/main" id="{902C5779-F2D5-4D49-A36C-3636A745FECE}"/>
                </a:ext>
              </a:extLst>
            </p:cNvPr>
            <p:cNvSpPr/>
            <p:nvPr/>
          </p:nvSpPr>
          <p:spPr>
            <a:xfrm>
              <a:off x="2238576" y="2696477"/>
              <a:ext cx="520700" cy="91440"/>
            </a:xfrm>
            <a:prstGeom prst="flowChartInputOutput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en-GB" sz="1100"/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9824E21F-BFA2-A64C-BE9C-8DA805F4561F}"/>
              </a:ext>
            </a:extLst>
          </p:cNvPr>
          <p:cNvGrpSpPr/>
          <p:nvPr/>
        </p:nvGrpSpPr>
        <p:grpSpPr>
          <a:xfrm>
            <a:off x="6604883" y="1413434"/>
            <a:ext cx="4398080" cy="4127051"/>
            <a:chOff x="7045588" y="1525736"/>
            <a:chExt cx="4398080" cy="4127051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457AD1D3-0DC5-D84A-AB2C-7606C7FF752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045588" y="3563699"/>
              <a:ext cx="4398080" cy="2089088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84F7DD7B-8BB7-8D4B-82C4-1E17D3C6500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068738" y="1525736"/>
              <a:ext cx="3888794" cy="1866900"/>
            </a:xfrm>
            <a:prstGeom prst="rect">
              <a:avLst/>
            </a:prstGeom>
          </p:spPr>
        </p:pic>
        <p:sp>
          <p:nvSpPr>
            <p:cNvPr id="16" name="Data 15">
              <a:extLst>
                <a:ext uri="{FF2B5EF4-FFF2-40B4-BE49-F238E27FC236}">
                  <a16:creationId xmlns:a16="http://schemas.microsoft.com/office/drawing/2014/main" id="{65149971-E91A-EE4C-B170-FBEB8D912F48}"/>
                </a:ext>
              </a:extLst>
            </p:cNvPr>
            <p:cNvSpPr/>
            <p:nvPr/>
          </p:nvSpPr>
          <p:spPr>
            <a:xfrm>
              <a:off x="7282948" y="3398648"/>
              <a:ext cx="520700" cy="91440"/>
            </a:xfrm>
            <a:prstGeom prst="flowChartInputOutput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en-GB" sz="1100"/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4325A996-31BD-0142-AA62-EA9C5B5237BF}"/>
              </a:ext>
            </a:extLst>
          </p:cNvPr>
          <p:cNvGrpSpPr/>
          <p:nvPr/>
        </p:nvGrpSpPr>
        <p:grpSpPr>
          <a:xfrm>
            <a:off x="7986451" y="900110"/>
            <a:ext cx="4084723" cy="3634973"/>
            <a:chOff x="7951726" y="772787"/>
            <a:chExt cx="4084723" cy="3634973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7911E60D-CC95-044C-9BC8-512815BFD36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998793" y="2731360"/>
              <a:ext cx="4037656" cy="167640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FCAB561F-4315-0749-B265-59CCAB70390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951726" y="772787"/>
              <a:ext cx="3888794" cy="1866900"/>
            </a:xfrm>
            <a:prstGeom prst="rect">
              <a:avLst/>
            </a:prstGeom>
          </p:spPr>
        </p:pic>
        <p:sp>
          <p:nvSpPr>
            <p:cNvPr id="19" name="Data 18">
              <a:extLst>
                <a:ext uri="{FF2B5EF4-FFF2-40B4-BE49-F238E27FC236}">
                  <a16:creationId xmlns:a16="http://schemas.microsoft.com/office/drawing/2014/main" id="{220D224D-3868-3A4B-9B95-0B1D6BA30EA3}"/>
                </a:ext>
              </a:extLst>
            </p:cNvPr>
            <p:cNvSpPr/>
            <p:nvPr/>
          </p:nvSpPr>
          <p:spPr>
            <a:xfrm>
              <a:off x="8201530" y="2622333"/>
              <a:ext cx="520700" cy="91440"/>
            </a:xfrm>
            <a:prstGeom prst="flowChartInputOutput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en-GB" sz="1100"/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9BBAD37E-7FDC-E147-8E2C-D4B40851683B}"/>
              </a:ext>
            </a:extLst>
          </p:cNvPr>
          <p:cNvSpPr txBox="1"/>
          <p:nvPr/>
        </p:nvSpPr>
        <p:spPr>
          <a:xfrm>
            <a:off x="33968" y="6326235"/>
            <a:ext cx="118539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Supplementary </a:t>
            </a:r>
            <a:r>
              <a:rPr lang="en-BG" sz="1400" b="1">
                <a:latin typeface="Arial Narrow" panose="020B0604020202020204" pitchFamily="34" charset="0"/>
                <a:cs typeface="Arial Narrow" panose="020B0604020202020204" pitchFamily="34" charset="0"/>
              </a:rPr>
              <a:t>Figure </a:t>
            </a:r>
            <a:r>
              <a:rPr lang="en-BG" sz="14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5</a:t>
            </a:r>
            <a:r>
              <a:rPr lang="en-BG" sz="1400" b="1">
                <a:latin typeface="Arial Narrow" panose="020B0604020202020204" pitchFamily="34" charset="0"/>
                <a:cs typeface="Arial Narrow" panose="020B0604020202020204" pitchFamily="34" charset="0"/>
              </a:rPr>
              <a:t>. </a:t>
            </a:r>
            <a:r>
              <a:rPr lang="en-BG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Cell distribution of </a:t>
            </a:r>
            <a:r>
              <a:rPr lang="en-GB" sz="14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sceSNVs</a:t>
            </a:r>
            <a:r>
              <a:rPr lang="en-GB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 across the 4 time-points of anticancer treatment of MCF7</a:t>
            </a:r>
            <a:r>
              <a:rPr lang="en-BG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. Between 318 and 636 </a:t>
            </a:r>
            <a:r>
              <a:rPr lang="en-GB" sz="14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sceSNVs</a:t>
            </a:r>
            <a:r>
              <a:rPr lang="en-GB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 were called in more than one cell.</a:t>
            </a:r>
            <a:endParaRPr lang="en-BG" sz="14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5C16078-DE75-134F-AAFB-929B70F236E7}"/>
              </a:ext>
            </a:extLst>
          </p:cNvPr>
          <p:cNvSpPr txBox="1"/>
          <p:nvPr/>
        </p:nvSpPr>
        <p:spPr>
          <a:xfrm>
            <a:off x="2513597" y="5549412"/>
            <a:ext cx="484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dirty="0"/>
              <a:t>t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C92E685-C6A1-2F4A-8F11-3516FD48F508}"/>
              </a:ext>
            </a:extLst>
          </p:cNvPr>
          <p:cNvSpPr txBox="1"/>
          <p:nvPr/>
        </p:nvSpPr>
        <p:spPr>
          <a:xfrm>
            <a:off x="4259635" y="4615485"/>
            <a:ext cx="568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dirty="0"/>
              <a:t>t1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0C07CB8-B4EA-0946-89CB-C4AA7CACE27B}"/>
              </a:ext>
            </a:extLst>
          </p:cNvPr>
          <p:cNvSpPr txBox="1"/>
          <p:nvPr/>
        </p:nvSpPr>
        <p:spPr>
          <a:xfrm>
            <a:off x="8827072" y="5580516"/>
            <a:ext cx="568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dirty="0"/>
              <a:t>t4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F3546FF-BDB9-E14F-B656-AEF0DB369E12}"/>
              </a:ext>
            </a:extLst>
          </p:cNvPr>
          <p:cNvSpPr txBox="1"/>
          <p:nvPr/>
        </p:nvSpPr>
        <p:spPr>
          <a:xfrm>
            <a:off x="9986036" y="4521480"/>
            <a:ext cx="568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dirty="0"/>
              <a:t>t96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1AAFA2D-1326-DB46-8EA0-FAC575FA6872}"/>
              </a:ext>
            </a:extLst>
          </p:cNvPr>
          <p:cNvSpPr txBox="1"/>
          <p:nvPr/>
        </p:nvSpPr>
        <p:spPr>
          <a:xfrm>
            <a:off x="7076409" y="5581130"/>
            <a:ext cx="1072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dirty="0"/>
              <a:t>N cells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4D27E19-42CC-034A-BB6E-AAFDCF866BF5}"/>
              </a:ext>
            </a:extLst>
          </p:cNvPr>
          <p:cNvSpPr txBox="1"/>
          <p:nvPr/>
        </p:nvSpPr>
        <p:spPr>
          <a:xfrm rot="16200000">
            <a:off x="6068798" y="4816233"/>
            <a:ext cx="1072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dirty="0"/>
              <a:t>N SNV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ECC2CBE-4273-254B-A0F8-5C6407DEC7FE}"/>
              </a:ext>
            </a:extLst>
          </p:cNvPr>
          <p:cNvSpPr txBox="1"/>
          <p:nvPr/>
        </p:nvSpPr>
        <p:spPr>
          <a:xfrm>
            <a:off x="8364392" y="4552670"/>
            <a:ext cx="1072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dirty="0"/>
              <a:t>N cell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4B9080A-4D2F-8E40-BC96-5F4EB787F322}"/>
              </a:ext>
            </a:extLst>
          </p:cNvPr>
          <p:cNvSpPr txBox="1"/>
          <p:nvPr/>
        </p:nvSpPr>
        <p:spPr>
          <a:xfrm rot="16200000">
            <a:off x="7356781" y="3787773"/>
            <a:ext cx="1072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dirty="0"/>
              <a:t>N SNV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5C64E67-CA4A-8E46-B987-C3C47B334FD7}"/>
              </a:ext>
            </a:extLst>
          </p:cNvPr>
          <p:cNvSpPr txBox="1"/>
          <p:nvPr/>
        </p:nvSpPr>
        <p:spPr>
          <a:xfrm>
            <a:off x="2419195" y="4624606"/>
            <a:ext cx="1072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dirty="0"/>
              <a:t>N cell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4178B41-1BE8-8C4E-B7A6-32C92D6FABC8}"/>
              </a:ext>
            </a:extLst>
          </p:cNvPr>
          <p:cNvSpPr txBox="1"/>
          <p:nvPr/>
        </p:nvSpPr>
        <p:spPr>
          <a:xfrm rot="16200000">
            <a:off x="1411584" y="3859709"/>
            <a:ext cx="1072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dirty="0"/>
              <a:t>N SNV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2B3EDF5-842C-AD43-8C64-475B5989F052}"/>
              </a:ext>
            </a:extLst>
          </p:cNvPr>
          <p:cNvSpPr txBox="1"/>
          <p:nvPr/>
        </p:nvSpPr>
        <p:spPr>
          <a:xfrm>
            <a:off x="677444" y="5549412"/>
            <a:ext cx="1072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dirty="0"/>
              <a:t>N cell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4FB90D8-BF67-B645-9557-586AC9E99FE9}"/>
              </a:ext>
            </a:extLst>
          </p:cNvPr>
          <p:cNvSpPr txBox="1"/>
          <p:nvPr/>
        </p:nvSpPr>
        <p:spPr>
          <a:xfrm rot="16200000">
            <a:off x="-330167" y="4784515"/>
            <a:ext cx="1072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dirty="0"/>
              <a:t>N SNVs</a:t>
            </a:r>
          </a:p>
        </p:txBody>
      </p:sp>
    </p:spTree>
    <p:extLst>
      <p:ext uri="{BB962C8B-B14F-4D97-AF65-F5344CB8AC3E}">
        <p14:creationId xmlns:p14="http://schemas.microsoft.com/office/powerpoint/2010/main" val="2083788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59</TotalTime>
  <Words>51</Words>
  <Application>Microsoft Macintosh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rvath, Anelia Dafinova</dc:creator>
  <cp:lastModifiedBy>Horvath, Anelia Dafinova</cp:lastModifiedBy>
  <cp:revision>9</cp:revision>
  <dcterms:created xsi:type="dcterms:W3CDTF">2021-06-01T18:15:27Z</dcterms:created>
  <dcterms:modified xsi:type="dcterms:W3CDTF">2021-09-26T13:27:42Z</dcterms:modified>
</cp:coreProperties>
</file>